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D04601D-2E00-4E57-9ECF-87FFB4E3718F}" v="10" dt="2021-06-02T17:52:19.5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992" y="-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ED04601D-2E00-4E57-9ECF-87FFB4E3718F}"/>
    <pc:docChg chg="modSld">
      <pc:chgData name="Fernanda Erpel" userId="29d1baa5783f2a02" providerId="LiveId" clId="{ED04601D-2E00-4E57-9ECF-87FFB4E3718F}" dt="2021-06-02T17:52:18.861" v="25"/>
      <pc:docMkLst>
        <pc:docMk/>
      </pc:docMkLst>
      <pc:sldChg chg="modSp mod">
        <pc:chgData name="Fernanda Erpel" userId="29d1baa5783f2a02" providerId="LiveId" clId="{ED04601D-2E00-4E57-9ECF-87FFB4E3718F}" dt="2021-06-02T17:52:18.861" v="25"/>
        <pc:sldMkLst>
          <pc:docMk/>
          <pc:sldMk cId="2944046250" sldId="256"/>
        </pc:sldMkLst>
        <pc:spChg chg="mod">
          <ac:chgData name="Fernanda Erpel" userId="29d1baa5783f2a02" providerId="LiveId" clId="{ED04601D-2E00-4E57-9ECF-87FFB4E3718F}" dt="2021-06-02T17:51:28.011" v="20" actId="2711"/>
          <ac:spMkLst>
            <pc:docMk/>
            <pc:sldMk cId="2944046250" sldId="256"/>
            <ac:spMk id="4" creationId="{211E712D-0C79-45FE-82BF-5DEDEA8C9E9F}"/>
          </ac:spMkLst>
        </pc:spChg>
        <pc:graphicFrameChg chg="mod">
          <ac:chgData name="Fernanda Erpel" userId="29d1baa5783f2a02" providerId="LiveId" clId="{ED04601D-2E00-4E57-9ECF-87FFB4E3718F}" dt="2021-06-02T17:52:18.861" v="25"/>
          <ac:graphicFrameMkLst>
            <pc:docMk/>
            <pc:sldMk cId="2944046250" sldId="256"/>
            <ac:graphicFrameMk id="6" creationId="{34C59053-8002-405C-8521-5D1C2CEB25C1}"/>
          </ac:graphicFrameMkLst>
        </pc:graphicFrameChg>
      </pc:sldChg>
    </pc:docChg>
  </pc:docChgLst>
  <pc:docChgLst>
    <pc:chgData name="Fernanda Erpel" userId="29d1baa5783f2a02" providerId="LiveId" clId="{54CCDBC2-4A4E-47C5-9E22-4FE5043CBD95}"/>
    <pc:docChg chg="undo custSel modSld">
      <pc:chgData name="Fernanda Erpel" userId="29d1baa5783f2a02" providerId="LiveId" clId="{54CCDBC2-4A4E-47C5-9E22-4FE5043CBD95}" dt="2021-02-23T21:17:09.004" v="176"/>
      <pc:docMkLst>
        <pc:docMk/>
      </pc:docMkLst>
      <pc:sldChg chg="addSp delSp modSp mod">
        <pc:chgData name="Fernanda Erpel" userId="29d1baa5783f2a02" providerId="LiveId" clId="{54CCDBC2-4A4E-47C5-9E22-4FE5043CBD95}" dt="2021-02-23T21:17:09.004" v="176"/>
        <pc:sldMkLst>
          <pc:docMk/>
          <pc:sldMk cId="2944046250" sldId="256"/>
        </pc:sldMkLst>
        <pc:spChg chg="mod">
          <ac:chgData name="Fernanda Erpel" userId="29d1baa5783f2a02" providerId="LiveId" clId="{54CCDBC2-4A4E-47C5-9E22-4FE5043CBD95}" dt="2021-01-21T17:10:41.109" v="165"/>
          <ac:spMkLst>
            <pc:docMk/>
            <pc:sldMk cId="2944046250" sldId="256"/>
            <ac:spMk id="4" creationId="{211E712D-0C79-45FE-82BF-5DEDEA8C9E9F}"/>
          </ac:spMkLst>
        </pc:spChg>
        <pc:graphicFrameChg chg="add del mod">
          <ac:chgData name="Fernanda Erpel" userId="29d1baa5783f2a02" providerId="LiveId" clId="{54CCDBC2-4A4E-47C5-9E22-4FE5043CBD95}" dt="2021-01-20T01:32:10.008" v="85" actId="478"/>
          <ac:graphicFrameMkLst>
            <pc:docMk/>
            <pc:sldMk cId="2944046250" sldId="256"/>
            <ac:graphicFrameMk id="5" creationId="{8A12B4D4-D1C9-4E53-9947-41681FF2A569}"/>
          </ac:graphicFrameMkLst>
        </pc:graphicFrameChg>
        <pc:graphicFrameChg chg="add mod">
          <ac:chgData name="Fernanda Erpel" userId="29d1baa5783f2a02" providerId="LiveId" clId="{54CCDBC2-4A4E-47C5-9E22-4FE5043CBD95}" dt="2021-02-23T21:17:09.004" v="176"/>
          <ac:graphicFrameMkLst>
            <pc:docMk/>
            <pc:sldMk cId="2944046250" sldId="256"/>
            <ac:graphicFrameMk id="6" creationId="{34C59053-8002-405C-8521-5D1C2CEB25C1}"/>
          </ac:graphicFrameMkLst>
        </pc:graphicFrameChg>
      </pc:sldChg>
    </pc:docChg>
  </pc:docChgLst>
  <pc:docChgLst>
    <pc:chgData name="Fernanda Erpel" userId="29d1baa5783f2a02" providerId="LiveId" clId="{E4D9CF14-5EFB-4937-A829-004E38F7DE02}"/>
    <pc:docChg chg="modSld">
      <pc:chgData name="Fernanda Erpel" userId="29d1baa5783f2a02" providerId="LiveId" clId="{E4D9CF14-5EFB-4937-A829-004E38F7DE02}" dt="2021-03-19T19:42:37.254" v="4" actId="20577"/>
      <pc:docMkLst>
        <pc:docMk/>
      </pc:docMkLst>
      <pc:sldChg chg="modSp mod">
        <pc:chgData name="Fernanda Erpel" userId="29d1baa5783f2a02" providerId="LiveId" clId="{E4D9CF14-5EFB-4937-A829-004E38F7DE02}" dt="2021-03-19T19:42:37.254" v="4" actId="20577"/>
        <pc:sldMkLst>
          <pc:docMk/>
          <pc:sldMk cId="2944046250" sldId="256"/>
        </pc:sldMkLst>
        <pc:spChg chg="mod">
          <ac:chgData name="Fernanda Erpel" userId="29d1baa5783f2a02" providerId="LiveId" clId="{E4D9CF14-5EFB-4937-A829-004E38F7DE02}" dt="2021-03-19T19:42:37.254" v="4" actId="20577"/>
          <ac:spMkLst>
            <pc:docMk/>
            <pc:sldMk cId="2944046250" sldId="256"/>
            <ac:spMk id="4" creationId="{211E712D-0C79-45FE-82BF-5DEDEA8C9E9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5203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634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253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743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21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741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787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3796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55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203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688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62938-8346-4EB8-A487-0F8FF1C36EDB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D3533-355B-47EB-AB4E-C8DF3F289C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826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11E712D-0C79-45FE-82BF-5DEDEA8C9E9F}"/>
              </a:ext>
            </a:extLst>
          </p:cNvPr>
          <p:cNvSpPr txBox="1"/>
          <p:nvPr/>
        </p:nvSpPr>
        <p:spPr>
          <a:xfrm>
            <a:off x="471681" y="419060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5. </a:t>
            </a:r>
            <a:r>
              <a:rPr lang="en-US" sz="900" dirty="0">
                <a:latin typeface="Palatino Linotype" panose="02040502050505030304" pitchFamily="18" charset="0"/>
              </a:rPr>
              <a:t>Multiple comparisons Tukey post hoc tests performed on the IC</a:t>
            </a:r>
            <a:r>
              <a:rPr lang="en-US" sz="900" baseline="-25000" dirty="0">
                <a:latin typeface="Palatino Linotype" panose="02040502050505030304" pitchFamily="18" charset="0"/>
              </a:rPr>
              <a:t>50</a:t>
            </a:r>
            <a:r>
              <a:rPr lang="en-US" sz="900" dirty="0">
                <a:latin typeface="Palatino Linotype" panose="02040502050505030304" pitchFamily="18" charset="0"/>
              </a:rPr>
              <a:t> values of the PHLE extracts and acarbose against 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</a:rPr>
              <a:t>-glucosidase activity. Statistically significant difference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denoted by asterisks.</a:t>
            </a:r>
          </a:p>
        </p:txBody>
      </p:sp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34C59053-8002-405C-8521-5D1C2CEB25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0177572"/>
              </p:ext>
            </p:extLst>
          </p:nvPr>
        </p:nvGraphicFramePr>
        <p:xfrm>
          <a:off x="1509713" y="873125"/>
          <a:ext cx="3667125" cy="589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3667169" imgH="5896103" progId="Excel.Sheet.12">
                  <p:embed/>
                </p:oleObj>
              </mc:Choice>
              <mc:Fallback>
                <p:oleObj name="Worksheet" r:id="rId2" imgW="3667169" imgH="5896103" progId="Excel.Sheet.12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34C59053-8002-405C-8521-5D1C2CEB25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09713" y="873125"/>
                        <a:ext cx="3667125" cy="589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440462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37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1</cp:revision>
  <dcterms:created xsi:type="dcterms:W3CDTF">2021-01-20T01:28:13Z</dcterms:created>
  <dcterms:modified xsi:type="dcterms:W3CDTF">2021-06-02T17:52:19Z</dcterms:modified>
</cp:coreProperties>
</file>